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FACS%20AND%20BUdding%20analysis\gsy2tps1tsl1%20overexpression%20on%20viability%20of%20rimyakmck%20double%20mutants\Viability%20in%20water%20repeat%20experiment\Sep%202015\Vialibity%20in%20water%20combined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H:\FACS%20AND%20BUdding%20analysis\gsy2tps1tsl1%20overexpression%20on%20viability%20of%20rimyakmck%20double%20mutants\Viability%20in%20water%20repeat%20experiment\Sep%202015\Vialibity%20in%20water%20combined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FACS%20AND%20BUdding%20analysis\gsy2tps1tsl1%20overexpression%20on%20viability%20of%20rimyakmck%20double%20mutants\Viability%20in%20water%20repeat%20experiment\Sep%202015\Vialibity%20in%20water%20combin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autoTitleDeleted val="1"/>
    <c:plotArea>
      <c:layout>
        <c:manualLayout>
          <c:layoutTarget val="inner"/>
          <c:xMode val="edge"/>
          <c:yMode val="edge"/>
          <c:x val="0.14322193367403621"/>
          <c:y val="3.3634283690701032E-2"/>
          <c:w val="0.92781714785651759"/>
          <c:h val="0.87899993661447295"/>
        </c:manualLayout>
      </c:layout>
      <c:lineChart>
        <c:grouping val="standard"/>
        <c:ser>
          <c:idx val="0"/>
          <c:order val="0"/>
          <c:tx>
            <c:v>WT pRS425/pRS426</c:v>
          </c:tx>
          <c:spPr>
            <a:ln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4:$H$4</c:f>
                <c:numCache>
                  <c:formatCode>General</c:formatCode>
                  <c:ptCount val="6"/>
                  <c:pt idx="0">
                    <c:v>0.51961524227108447</c:v>
                  </c:pt>
                  <c:pt idx="1">
                    <c:v>0.25166114784235816</c:v>
                  </c:pt>
                  <c:pt idx="2">
                    <c:v>9.9999999999994579E-2</c:v>
                  </c:pt>
                  <c:pt idx="3">
                    <c:v>5.773502691895941E-2</c:v>
                  </c:pt>
                  <c:pt idx="4">
                    <c:v>0.37859388971774494</c:v>
                  </c:pt>
                  <c:pt idx="5">
                    <c:v>0.15275252316519394</c:v>
                  </c:pt>
                </c:numCache>
              </c:numRef>
            </c:plus>
            <c:minus>
              <c:numRef>
                <c:f>'viability in water and SC'!$C$4:$H$4</c:f>
                <c:numCache>
                  <c:formatCode>General</c:formatCode>
                  <c:ptCount val="6"/>
                  <c:pt idx="0">
                    <c:v>0.51961524227108447</c:v>
                  </c:pt>
                  <c:pt idx="1">
                    <c:v>0.25166114784235816</c:v>
                  </c:pt>
                  <c:pt idx="2">
                    <c:v>9.9999999999994579E-2</c:v>
                  </c:pt>
                  <c:pt idx="3">
                    <c:v>5.773502691895941E-2</c:v>
                  </c:pt>
                  <c:pt idx="4">
                    <c:v>0.37859388971774494</c:v>
                  </c:pt>
                  <c:pt idx="5">
                    <c:v>0.15275252316519394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3:$H$3</c:f>
              <c:numCache>
                <c:formatCode>General</c:formatCode>
                <c:ptCount val="6"/>
                <c:pt idx="0">
                  <c:v>83.399999999999991</c:v>
                </c:pt>
                <c:pt idx="1">
                  <c:v>78.966666666666697</c:v>
                </c:pt>
                <c:pt idx="2">
                  <c:v>82</c:v>
                </c:pt>
                <c:pt idx="3">
                  <c:v>82.533333333333289</c:v>
                </c:pt>
                <c:pt idx="4">
                  <c:v>82.366666666666674</c:v>
                </c:pt>
                <c:pt idx="5">
                  <c:v>81.366666666666674</c:v>
                </c:pt>
              </c:numCache>
            </c:numRef>
          </c:val>
        </c:ser>
        <c:ser>
          <c:idx val="1"/>
          <c:order val="1"/>
          <c:tx>
            <c:v>WT GSY2/TPS1</c:v>
          </c:tx>
          <c:spPr>
            <a:ln>
              <a:solidFill>
                <a:srgbClr val="C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6:$H$6</c:f>
                <c:numCache>
                  <c:formatCode>General</c:formatCode>
                  <c:ptCount val="6"/>
                  <c:pt idx="0">
                    <c:v>0.55677643628254603</c:v>
                  </c:pt>
                  <c:pt idx="1">
                    <c:v>0.41633319989412948</c:v>
                  </c:pt>
                  <c:pt idx="2">
                    <c:v>0.472581562625287</c:v>
                  </c:pt>
                  <c:pt idx="3">
                    <c:v>0.10000000000000142</c:v>
                  </c:pt>
                  <c:pt idx="4">
                    <c:v>0.37859388972254954</c:v>
                  </c:pt>
                  <c:pt idx="5">
                    <c:v>0.7999999999985008</c:v>
                  </c:pt>
                </c:numCache>
              </c:numRef>
            </c:plus>
            <c:minus>
              <c:numRef>
                <c:f>'viability in water and SC'!$C$6:$H$6</c:f>
                <c:numCache>
                  <c:formatCode>General</c:formatCode>
                  <c:ptCount val="6"/>
                  <c:pt idx="0">
                    <c:v>0.55677643628254603</c:v>
                  </c:pt>
                  <c:pt idx="1">
                    <c:v>0.41633319989412948</c:v>
                  </c:pt>
                  <c:pt idx="2">
                    <c:v>0.472581562625287</c:v>
                  </c:pt>
                  <c:pt idx="3">
                    <c:v>0.10000000000000142</c:v>
                  </c:pt>
                  <c:pt idx="4">
                    <c:v>0.37859388972254954</c:v>
                  </c:pt>
                  <c:pt idx="5">
                    <c:v>0.7999999999985008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5:$H$5</c:f>
              <c:numCache>
                <c:formatCode>General</c:formatCode>
                <c:ptCount val="6"/>
                <c:pt idx="0">
                  <c:v>83.600000000000009</c:v>
                </c:pt>
                <c:pt idx="1">
                  <c:v>80.466666666666697</c:v>
                </c:pt>
                <c:pt idx="2">
                  <c:v>81.733333333333249</c:v>
                </c:pt>
                <c:pt idx="3">
                  <c:v>82.3</c:v>
                </c:pt>
                <c:pt idx="4">
                  <c:v>82.633333333333155</c:v>
                </c:pt>
                <c:pt idx="5">
                  <c:v>81.600000000000009</c:v>
                </c:pt>
              </c:numCache>
            </c:numRef>
          </c:val>
        </c:ser>
        <c:ser>
          <c:idx val="2"/>
          <c:order val="2"/>
          <c:tx>
            <c:v>WT GSY2/TSL1</c:v>
          </c:tx>
          <c:spPr>
            <a:ln>
              <a:solidFill>
                <a:srgbClr val="92D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8:$H$8</c:f>
                <c:numCache>
                  <c:formatCode>General</c:formatCode>
                  <c:ptCount val="6"/>
                  <c:pt idx="0">
                    <c:v>0.45825756949463137</c:v>
                  </c:pt>
                  <c:pt idx="1">
                    <c:v>0.10000000000000142</c:v>
                  </c:pt>
                  <c:pt idx="2">
                    <c:v>0.36055512754528901</c:v>
                  </c:pt>
                  <c:pt idx="3">
                    <c:v>0.3055050463257849</c:v>
                  </c:pt>
                  <c:pt idx="4">
                    <c:v>0.529150262213538</c:v>
                  </c:pt>
                  <c:pt idx="5">
                    <c:v>0.23094010767585371</c:v>
                  </c:pt>
                </c:numCache>
              </c:numRef>
            </c:plus>
            <c:minus>
              <c:numRef>
                <c:f>'viability in water and SC'!$C$8:$H$8</c:f>
                <c:numCache>
                  <c:formatCode>General</c:formatCode>
                  <c:ptCount val="6"/>
                  <c:pt idx="0">
                    <c:v>0.45825756949463137</c:v>
                  </c:pt>
                  <c:pt idx="1">
                    <c:v>0.10000000000000142</c:v>
                  </c:pt>
                  <c:pt idx="2">
                    <c:v>0.36055512754528901</c:v>
                  </c:pt>
                  <c:pt idx="3">
                    <c:v>0.3055050463257849</c:v>
                  </c:pt>
                  <c:pt idx="4">
                    <c:v>0.529150262213538</c:v>
                  </c:pt>
                  <c:pt idx="5">
                    <c:v>0.23094010767585371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7:$H$7</c:f>
              <c:numCache>
                <c:formatCode>General</c:formatCode>
                <c:ptCount val="6"/>
                <c:pt idx="0">
                  <c:v>84.7</c:v>
                </c:pt>
                <c:pt idx="1">
                  <c:v>81.599999999999994</c:v>
                </c:pt>
                <c:pt idx="2">
                  <c:v>83.500000000000014</c:v>
                </c:pt>
                <c:pt idx="3">
                  <c:v>82.866666666666674</c:v>
                </c:pt>
                <c:pt idx="4">
                  <c:v>82.899999999999991</c:v>
                </c:pt>
                <c:pt idx="5">
                  <c:v>79.633333333333169</c:v>
                </c:pt>
              </c:numCache>
            </c:numRef>
          </c:val>
        </c:ser>
        <c:marker val="1"/>
        <c:axId val="47125248"/>
        <c:axId val="47127552"/>
      </c:lineChart>
      <c:catAx>
        <c:axId val="47125248"/>
        <c:scaling>
          <c:orientation val="minMax"/>
        </c:scaling>
        <c:axPos val="b"/>
        <c:numFmt formatCode="General" sourceLinked="1"/>
        <c:tickLblPos val="nextTo"/>
        <c:crossAx val="47127552"/>
        <c:crosses val="autoZero"/>
        <c:auto val="1"/>
        <c:lblAlgn val="ctr"/>
        <c:lblOffset val="100"/>
      </c:catAx>
      <c:valAx>
        <c:axId val="47127552"/>
        <c:scaling>
          <c:orientation val="minMax"/>
          <c:max val="100"/>
          <c:min val="0"/>
        </c:scaling>
        <c:axPos val="l"/>
        <c:majorGridlines/>
        <c:numFmt formatCode="General" sourceLinked="1"/>
        <c:tickLblPos val="nextTo"/>
        <c:crossAx val="47125248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15235373152983031"/>
          <c:y val="0.56261066478724475"/>
          <c:w val="0.59878254133508357"/>
          <c:h val="0.28294425619375635"/>
        </c:manualLayout>
      </c:layout>
      <c:txPr>
        <a:bodyPr/>
        <a:lstStyle/>
        <a:p>
          <a:pPr>
            <a:defRPr i="1"/>
          </a:pPr>
          <a:endParaRPr lang="en-US"/>
        </a:p>
      </c:txPr>
    </c:legend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0.13189894595148741"/>
          <c:y val="2.8320471298947856E-2"/>
          <c:w val="0.8681010540485149"/>
          <c:h val="0.87862415027075624"/>
        </c:manualLayout>
      </c:layout>
      <c:lineChart>
        <c:grouping val="standard"/>
        <c:ser>
          <c:idx val="3"/>
          <c:order val="0"/>
          <c:tx>
            <c:v>rim15∆yak1∆ pRS425/pRS426</c:v>
          </c:tx>
          <c:spPr>
            <a:ln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10:$H$10</c:f>
                <c:numCache>
                  <c:formatCode>General</c:formatCode>
                  <c:ptCount val="6"/>
                  <c:pt idx="0">
                    <c:v>0.36055512754781188</c:v>
                  </c:pt>
                  <c:pt idx="1">
                    <c:v>0.57735026918936316</c:v>
                  </c:pt>
                  <c:pt idx="2">
                    <c:v>0.73711147958178591</c:v>
                  </c:pt>
                  <c:pt idx="3">
                    <c:v>0.51316014394556153</c:v>
                  </c:pt>
                  <c:pt idx="4">
                    <c:v>0.85049005481075068</c:v>
                  </c:pt>
                  <c:pt idx="5">
                    <c:v>0.85440037453176376</c:v>
                  </c:pt>
                </c:numCache>
              </c:numRef>
            </c:plus>
            <c:minus>
              <c:numRef>
                <c:f>'viability in water and SC'!$C$10:$H$10</c:f>
                <c:numCache>
                  <c:formatCode>General</c:formatCode>
                  <c:ptCount val="6"/>
                  <c:pt idx="0">
                    <c:v>0.36055512754781188</c:v>
                  </c:pt>
                  <c:pt idx="1">
                    <c:v>0.57735026918936316</c:v>
                  </c:pt>
                  <c:pt idx="2">
                    <c:v>0.73711147958178591</c:v>
                  </c:pt>
                  <c:pt idx="3">
                    <c:v>0.51316014394556153</c:v>
                  </c:pt>
                  <c:pt idx="4">
                    <c:v>0.85049005481075068</c:v>
                  </c:pt>
                  <c:pt idx="5">
                    <c:v>0.85440037453176376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9:$H$9</c:f>
              <c:numCache>
                <c:formatCode>General</c:formatCode>
                <c:ptCount val="6"/>
                <c:pt idx="0">
                  <c:v>77.100000000000009</c:v>
                </c:pt>
                <c:pt idx="1">
                  <c:v>73.233333333333249</c:v>
                </c:pt>
                <c:pt idx="2">
                  <c:v>74.266666666666666</c:v>
                </c:pt>
                <c:pt idx="3">
                  <c:v>64.566666666666663</c:v>
                </c:pt>
                <c:pt idx="4">
                  <c:v>49.366666666666497</c:v>
                </c:pt>
                <c:pt idx="5">
                  <c:v>33</c:v>
                </c:pt>
              </c:numCache>
            </c:numRef>
          </c:val>
        </c:ser>
        <c:ser>
          <c:idx val="4"/>
          <c:order val="1"/>
          <c:tx>
            <c:v>rim15∆yak1∆ GSY2/TPS1</c:v>
          </c:tx>
          <c:spPr>
            <a:ln>
              <a:solidFill>
                <a:srgbClr val="C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12:$H$12</c:f>
                <c:numCache>
                  <c:formatCode>General</c:formatCode>
                  <c:ptCount val="6"/>
                  <c:pt idx="0">
                    <c:v>0.15275252316519244</c:v>
                  </c:pt>
                  <c:pt idx="1">
                    <c:v>0.65064070986674682</c:v>
                  </c:pt>
                  <c:pt idx="2">
                    <c:v>0.61101009266050277</c:v>
                  </c:pt>
                  <c:pt idx="3">
                    <c:v>0.45092497528082509</c:v>
                  </c:pt>
                  <c:pt idx="4">
                    <c:v>0.69999999999984464</c:v>
                  </c:pt>
                  <c:pt idx="5">
                    <c:v>9.9999999999999922E-2</c:v>
                  </c:pt>
                </c:numCache>
              </c:numRef>
            </c:plus>
            <c:minus>
              <c:numRef>
                <c:f>'viability in water and SC'!$C$12:$H$12</c:f>
                <c:numCache>
                  <c:formatCode>General</c:formatCode>
                  <c:ptCount val="6"/>
                  <c:pt idx="0">
                    <c:v>0.15275252316519244</c:v>
                  </c:pt>
                  <c:pt idx="1">
                    <c:v>0.65064070986674682</c:v>
                  </c:pt>
                  <c:pt idx="2">
                    <c:v>0.61101009266050277</c:v>
                  </c:pt>
                  <c:pt idx="3">
                    <c:v>0.45092497528082509</c:v>
                  </c:pt>
                  <c:pt idx="4">
                    <c:v>0.69999999999984464</c:v>
                  </c:pt>
                  <c:pt idx="5">
                    <c:v>9.9999999999999922E-2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11:$H$11</c:f>
              <c:numCache>
                <c:formatCode>General</c:formatCode>
                <c:ptCount val="6"/>
                <c:pt idx="0">
                  <c:v>84.066666666666677</c:v>
                </c:pt>
                <c:pt idx="1">
                  <c:v>80.86666666666666</c:v>
                </c:pt>
                <c:pt idx="2">
                  <c:v>77.733333333333249</c:v>
                </c:pt>
                <c:pt idx="3">
                  <c:v>64.266666666666666</c:v>
                </c:pt>
                <c:pt idx="4">
                  <c:v>52.6</c:v>
                </c:pt>
                <c:pt idx="5">
                  <c:v>31.8</c:v>
                </c:pt>
              </c:numCache>
            </c:numRef>
          </c:val>
        </c:ser>
        <c:ser>
          <c:idx val="5"/>
          <c:order val="2"/>
          <c:tx>
            <c:v>rim15∆yak1∆ GSY2/TSL1</c:v>
          </c:tx>
          <c:spPr>
            <a:ln>
              <a:solidFill>
                <a:srgbClr val="92D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14:$H$14</c:f>
                <c:numCache>
                  <c:formatCode>General</c:formatCode>
                  <c:ptCount val="6"/>
                  <c:pt idx="0">
                    <c:v>0.26457513110645747</c:v>
                  </c:pt>
                  <c:pt idx="1">
                    <c:v>0</c:v>
                  </c:pt>
                  <c:pt idx="2">
                    <c:v>0.43588989435047987</c:v>
                  </c:pt>
                  <c:pt idx="3">
                    <c:v>0.529150262213538</c:v>
                  </c:pt>
                  <c:pt idx="4">
                    <c:v>0.2645751311064603</c:v>
                  </c:pt>
                  <c:pt idx="5">
                    <c:v>0.63508529610740583</c:v>
                  </c:pt>
                </c:numCache>
              </c:numRef>
            </c:plus>
            <c:minus>
              <c:numRef>
                <c:f>'viability in water and SC'!$C$14:$H$14</c:f>
                <c:numCache>
                  <c:formatCode>General</c:formatCode>
                  <c:ptCount val="6"/>
                  <c:pt idx="0">
                    <c:v>0.26457513110645747</c:v>
                  </c:pt>
                  <c:pt idx="1">
                    <c:v>0</c:v>
                  </c:pt>
                  <c:pt idx="2">
                    <c:v>0.43588989435047987</c:v>
                  </c:pt>
                  <c:pt idx="3">
                    <c:v>0.529150262213538</c:v>
                  </c:pt>
                  <c:pt idx="4">
                    <c:v>0.2645751311064603</c:v>
                  </c:pt>
                  <c:pt idx="5">
                    <c:v>0.63508529610740583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13:$H$13</c:f>
              <c:numCache>
                <c:formatCode>General</c:formatCode>
                <c:ptCount val="6"/>
                <c:pt idx="0">
                  <c:v>80.3</c:v>
                </c:pt>
                <c:pt idx="1">
                  <c:v>75.7</c:v>
                </c:pt>
                <c:pt idx="2">
                  <c:v>78.400000000000006</c:v>
                </c:pt>
                <c:pt idx="3">
                  <c:v>79.600000000000009</c:v>
                </c:pt>
                <c:pt idx="4">
                  <c:v>78.7</c:v>
                </c:pt>
                <c:pt idx="5">
                  <c:v>74.966666666666697</c:v>
                </c:pt>
              </c:numCache>
            </c:numRef>
          </c:val>
        </c:ser>
        <c:marker val="1"/>
        <c:axId val="53097600"/>
        <c:axId val="53099520"/>
      </c:lineChart>
      <c:catAx>
        <c:axId val="53097600"/>
        <c:scaling>
          <c:orientation val="minMax"/>
        </c:scaling>
        <c:axPos val="b"/>
        <c:numFmt formatCode="General" sourceLinked="1"/>
        <c:tickLblPos val="nextTo"/>
        <c:crossAx val="53099520"/>
        <c:crosses val="autoZero"/>
        <c:auto val="1"/>
        <c:lblAlgn val="ctr"/>
        <c:lblOffset val="100"/>
      </c:catAx>
      <c:valAx>
        <c:axId val="53099520"/>
        <c:scaling>
          <c:orientation val="minMax"/>
          <c:max val="100"/>
          <c:min val="0"/>
        </c:scaling>
        <c:axPos val="l"/>
        <c:majorGridlines/>
        <c:numFmt formatCode="General" sourceLinked="1"/>
        <c:tickLblPos val="nextTo"/>
        <c:crossAx val="53097600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11342005770402615"/>
          <c:y val="0.58902595415871961"/>
          <c:w val="0.84965601465157314"/>
          <c:h val="0.28474886291387574"/>
        </c:manualLayout>
      </c:layout>
      <c:txPr>
        <a:bodyPr/>
        <a:lstStyle/>
        <a:p>
          <a:pPr>
            <a:defRPr i="1"/>
          </a:pPr>
          <a:endParaRPr lang="en-US"/>
        </a:p>
      </c:txPr>
    </c:legend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autoTitleDeleted val="1"/>
    <c:plotArea>
      <c:layout>
        <c:manualLayout>
          <c:layoutTarget val="inner"/>
          <c:xMode val="edge"/>
          <c:yMode val="edge"/>
          <c:x val="5.8099518810148937E-2"/>
          <c:y val="2.8320471298947856E-2"/>
          <c:w val="0.92781714785651759"/>
          <c:h val="0.87862415027075624"/>
        </c:manualLayout>
      </c:layout>
      <c:lineChart>
        <c:grouping val="standard"/>
        <c:ser>
          <c:idx val="6"/>
          <c:order val="0"/>
          <c:tx>
            <c:v>rim15∆mck1∆ pRS425/pRS426</c:v>
          </c:tx>
          <c:spPr>
            <a:ln>
              <a:solidFill>
                <a:srgbClr val="0070C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16:$H$16</c:f>
                <c:numCache>
                  <c:formatCode>General</c:formatCode>
                  <c:ptCount val="6"/>
                  <c:pt idx="0">
                    <c:v>0.34641016151427539</c:v>
                  </c:pt>
                  <c:pt idx="1">
                    <c:v>0.30550504633025038</c:v>
                  </c:pt>
                  <c:pt idx="2">
                    <c:v>0.15275252316519294</c:v>
                  </c:pt>
                  <c:pt idx="3">
                    <c:v>0.4163331998933103</c:v>
                  </c:pt>
                  <c:pt idx="4">
                    <c:v>0.36055512754686558</c:v>
                  </c:pt>
                  <c:pt idx="5">
                    <c:v>1.5502687938977531</c:v>
                  </c:pt>
                </c:numCache>
              </c:numRef>
            </c:plus>
            <c:minus>
              <c:numRef>
                <c:f>'viability in water and SC'!$C$16:$H$16</c:f>
                <c:numCache>
                  <c:formatCode>General</c:formatCode>
                  <c:ptCount val="6"/>
                  <c:pt idx="0">
                    <c:v>0.34641016151427539</c:v>
                  </c:pt>
                  <c:pt idx="1">
                    <c:v>0.30550504633025038</c:v>
                  </c:pt>
                  <c:pt idx="2">
                    <c:v>0.15275252316519294</c:v>
                  </c:pt>
                  <c:pt idx="3">
                    <c:v>0.4163331998933103</c:v>
                  </c:pt>
                  <c:pt idx="4">
                    <c:v>0.36055512754686558</c:v>
                  </c:pt>
                  <c:pt idx="5">
                    <c:v>1.5502687938977531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15:$H$15</c:f>
              <c:numCache>
                <c:formatCode>General</c:formatCode>
                <c:ptCount val="6"/>
                <c:pt idx="0">
                  <c:v>38.9</c:v>
                </c:pt>
                <c:pt idx="1">
                  <c:v>32.833333333333336</c:v>
                </c:pt>
                <c:pt idx="2">
                  <c:v>35.133333333333333</c:v>
                </c:pt>
                <c:pt idx="3">
                  <c:v>32.833333333333336</c:v>
                </c:pt>
                <c:pt idx="4">
                  <c:v>34.1</c:v>
                </c:pt>
                <c:pt idx="5">
                  <c:v>30.066666666666666</c:v>
                </c:pt>
              </c:numCache>
            </c:numRef>
          </c:val>
        </c:ser>
        <c:ser>
          <c:idx val="7"/>
          <c:order val="1"/>
          <c:tx>
            <c:v>rim15∆mck1∆ GSY2/TPS1</c:v>
          </c:tx>
          <c:spPr>
            <a:ln>
              <a:solidFill>
                <a:srgbClr val="C0000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18:$H$18</c:f>
                <c:numCache>
                  <c:formatCode>General</c:formatCode>
                  <c:ptCount val="6"/>
                  <c:pt idx="0">
                    <c:v>0.39999999999953501</c:v>
                  </c:pt>
                  <c:pt idx="1">
                    <c:v>0.15275252316475307</c:v>
                  </c:pt>
                  <c:pt idx="2">
                    <c:v>0.11547005383792475</c:v>
                  </c:pt>
                  <c:pt idx="3">
                    <c:v>0.35118845842842678</c:v>
                  </c:pt>
                  <c:pt idx="4">
                    <c:v>0.35118845842858865</c:v>
                  </c:pt>
                  <c:pt idx="5">
                    <c:v>0.50332229568460052</c:v>
                  </c:pt>
                </c:numCache>
              </c:numRef>
            </c:plus>
            <c:minus>
              <c:numRef>
                <c:f>'viability in water and SC'!$C$18:$H$18</c:f>
                <c:numCache>
                  <c:formatCode>General</c:formatCode>
                  <c:ptCount val="6"/>
                  <c:pt idx="0">
                    <c:v>0.39999999999953501</c:v>
                  </c:pt>
                  <c:pt idx="1">
                    <c:v>0.15275252316475307</c:v>
                  </c:pt>
                  <c:pt idx="2">
                    <c:v>0.11547005383792475</c:v>
                  </c:pt>
                  <c:pt idx="3">
                    <c:v>0.35118845842842678</c:v>
                  </c:pt>
                  <c:pt idx="4">
                    <c:v>0.35118845842858865</c:v>
                  </c:pt>
                  <c:pt idx="5">
                    <c:v>0.50332229568460052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17:$H$17</c:f>
              <c:numCache>
                <c:formatCode>General</c:formatCode>
                <c:ptCount val="6"/>
                <c:pt idx="0">
                  <c:v>28.3</c:v>
                </c:pt>
                <c:pt idx="1">
                  <c:v>21.466666666666669</c:v>
                </c:pt>
                <c:pt idx="2">
                  <c:v>22.166666666666668</c:v>
                </c:pt>
                <c:pt idx="3">
                  <c:v>19.566666666666666</c:v>
                </c:pt>
                <c:pt idx="4">
                  <c:v>23.533333333333264</c:v>
                </c:pt>
                <c:pt idx="5">
                  <c:v>19.866666666666667</c:v>
                </c:pt>
              </c:numCache>
            </c:numRef>
          </c:val>
        </c:ser>
        <c:ser>
          <c:idx val="8"/>
          <c:order val="2"/>
          <c:tx>
            <c:v>rim15∆mck1∆ GSY2/TSL1</c:v>
          </c:tx>
          <c:spPr>
            <a:ln>
              <a:solidFill>
                <a:srgbClr val="92D050"/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plus>
              <c:numRef>
                <c:f>'viability in water and SC'!$C$20:$H$20</c:f>
                <c:numCache>
                  <c:formatCode>General</c:formatCode>
                  <c:ptCount val="6"/>
                  <c:pt idx="0">
                    <c:v>0.77674534651541782</c:v>
                  </c:pt>
                  <c:pt idx="1">
                    <c:v>0.7094598884597566</c:v>
                  </c:pt>
                  <c:pt idx="2">
                    <c:v>0.36055512754655028</c:v>
                  </c:pt>
                  <c:pt idx="3">
                    <c:v>0.11547005383792475</c:v>
                  </c:pt>
                  <c:pt idx="4">
                    <c:v>0.15275252316512541</c:v>
                  </c:pt>
                  <c:pt idx="5">
                    <c:v>0.25166114784269561</c:v>
                  </c:pt>
                </c:numCache>
              </c:numRef>
            </c:plus>
            <c:minus>
              <c:numRef>
                <c:f>'viability in water and SC'!$C$20:$H$20</c:f>
                <c:numCache>
                  <c:formatCode>General</c:formatCode>
                  <c:ptCount val="6"/>
                  <c:pt idx="0">
                    <c:v>0.77674534651541782</c:v>
                  </c:pt>
                  <c:pt idx="1">
                    <c:v>0.7094598884597566</c:v>
                  </c:pt>
                  <c:pt idx="2">
                    <c:v>0.36055512754655028</c:v>
                  </c:pt>
                  <c:pt idx="3">
                    <c:v>0.11547005383792475</c:v>
                  </c:pt>
                  <c:pt idx="4">
                    <c:v>0.15275252316512541</c:v>
                  </c:pt>
                  <c:pt idx="5">
                    <c:v>0.25166114784269561</c:v>
                  </c:pt>
                </c:numCache>
              </c:numRef>
            </c:minus>
          </c:errBars>
          <c:cat>
            <c:numRef>
              <c:f>'viability in water and SC'!$C$2:$H$2</c:f>
              <c:numCache>
                <c:formatCode>General</c:formatCode>
                <c:ptCount val="6"/>
                <c:pt idx="0">
                  <c:v>0</c:v>
                </c:pt>
                <c:pt idx="1">
                  <c:v>3</c:v>
                </c:pt>
                <c:pt idx="2">
                  <c:v>6</c:v>
                </c:pt>
                <c:pt idx="3">
                  <c:v>9</c:v>
                </c:pt>
                <c:pt idx="4">
                  <c:v>12</c:v>
                </c:pt>
                <c:pt idx="5">
                  <c:v>16</c:v>
                </c:pt>
              </c:numCache>
            </c:numRef>
          </c:cat>
          <c:val>
            <c:numRef>
              <c:f>'viability in water and SC'!$C$19:$H$19</c:f>
              <c:numCache>
                <c:formatCode>General</c:formatCode>
                <c:ptCount val="6"/>
                <c:pt idx="0">
                  <c:v>25.333333333333275</c:v>
                </c:pt>
                <c:pt idx="1">
                  <c:v>21.133333333333283</c:v>
                </c:pt>
                <c:pt idx="2">
                  <c:v>23.099999999999987</c:v>
                </c:pt>
                <c:pt idx="3">
                  <c:v>20.666666666666668</c:v>
                </c:pt>
                <c:pt idx="4">
                  <c:v>22.566666666666666</c:v>
                </c:pt>
                <c:pt idx="5">
                  <c:v>19.533333333333264</c:v>
                </c:pt>
              </c:numCache>
            </c:numRef>
          </c:val>
        </c:ser>
        <c:marker val="1"/>
        <c:axId val="79760384"/>
        <c:axId val="86459904"/>
      </c:lineChart>
      <c:catAx>
        <c:axId val="79760384"/>
        <c:scaling>
          <c:orientation val="minMax"/>
        </c:scaling>
        <c:axPos val="b"/>
        <c:numFmt formatCode="General" sourceLinked="1"/>
        <c:tickLblPos val="nextTo"/>
        <c:crossAx val="86459904"/>
        <c:crosses val="autoZero"/>
        <c:auto val="1"/>
        <c:lblAlgn val="ctr"/>
        <c:lblOffset val="100"/>
      </c:catAx>
      <c:valAx>
        <c:axId val="86459904"/>
        <c:scaling>
          <c:orientation val="minMax"/>
          <c:max val="100"/>
          <c:min val="0"/>
        </c:scaling>
        <c:axPos val="l"/>
        <c:majorGridlines/>
        <c:numFmt formatCode="General" sourceLinked="1"/>
        <c:tickLblPos val="nextTo"/>
        <c:crossAx val="79760384"/>
        <c:crosses val="autoZero"/>
        <c:crossBetween val="between"/>
        <c:majorUnit val="20"/>
      </c:valAx>
    </c:plotArea>
    <c:legend>
      <c:legendPos val="r"/>
      <c:layout>
        <c:manualLayout>
          <c:xMode val="edge"/>
          <c:yMode val="edge"/>
          <c:x val="0.1709025902831095"/>
          <c:y val="9.4998559187868245E-2"/>
          <c:w val="0.78874669086385063"/>
          <c:h val="0.29714276538718004"/>
        </c:manualLayout>
      </c:layout>
      <c:txPr>
        <a:bodyPr/>
        <a:lstStyle/>
        <a:p>
          <a:pPr>
            <a:defRPr i="1"/>
          </a:pPr>
          <a:endParaRPr lang="en-US"/>
        </a:p>
      </c:txPr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917FF4-9EE1-4376-A255-90D790056EA6}" type="datetimeFigureOut">
              <a:rPr lang="en-GB" smtClean="0"/>
              <a:pPr/>
              <a:t>23/09/20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3812E-6278-4907-BB1A-C12E907AC28B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467545" y="1988840"/>
          <a:ext cx="2304256" cy="2304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3203849" y="1988840"/>
          <a:ext cx="2376264" cy="230425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6084169" y="1988840"/>
          <a:ext cx="2448272" cy="2304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 rot="16200000">
            <a:off x="-72607" y="2889031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Viability (%)</a:t>
            </a:r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2591689" y="2889031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Viability (%)</a:t>
            </a:r>
            <a:endParaRPr lang="en-GB" sz="1200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5472009" y="2889031"/>
            <a:ext cx="925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Viability (%)</a:t>
            </a:r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1331640" y="4293096"/>
            <a:ext cx="1025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s in water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4139952" y="4293096"/>
            <a:ext cx="1025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s in water</a:t>
            </a:r>
            <a:endParaRPr lang="en-GB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6948264" y="4293096"/>
            <a:ext cx="10251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/>
              <a:t>Days in water</a:t>
            </a:r>
            <a:endParaRPr lang="en-GB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467544" y="148478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5</a:t>
            </a:r>
            <a:r>
              <a:rPr lang="en-GB" sz="1200" b="1" dirty="0" smtClean="0"/>
              <a:t>a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203848" y="1484784"/>
            <a:ext cx="3465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5</a:t>
            </a:r>
            <a:r>
              <a:rPr lang="en-GB" sz="1200" b="1" dirty="0" smtClean="0"/>
              <a:t>b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6300192" y="1484784"/>
            <a:ext cx="3273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5</a:t>
            </a:r>
            <a:r>
              <a:rPr lang="en-GB" sz="1200" b="1" dirty="0" smtClean="0"/>
              <a:t>c</a:t>
            </a:r>
            <a:endParaRPr lang="en-GB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611560" y="908720"/>
            <a:ext cx="17404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Supplementary Figure  </a:t>
            </a:r>
            <a:r>
              <a:rPr lang="en-GB" sz="1200" b="1" dirty="0" smtClean="0"/>
              <a:t>5</a:t>
            </a:r>
            <a:endParaRPr lang="en-GB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21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Cambridg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z228</dc:creator>
  <cp:lastModifiedBy>nz228</cp:lastModifiedBy>
  <cp:revision>11</cp:revision>
  <dcterms:created xsi:type="dcterms:W3CDTF">2016-04-15T15:23:57Z</dcterms:created>
  <dcterms:modified xsi:type="dcterms:W3CDTF">2016-09-23T19:34:22Z</dcterms:modified>
</cp:coreProperties>
</file>